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 varScale="1">
        <p:scale>
          <a:sx n="98" d="100"/>
          <a:sy n="98" d="100"/>
        </p:scale>
        <p:origin x="-402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36" y="15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7C6B9C-109F-4A97-B107-8A339EE297B7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930DF4-A33C-4C53-92BB-ADA451148D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886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smtClean="0"/>
              <a:t>Table 1: Scoring of</a:t>
            </a:r>
            <a:r>
              <a:rPr lang="en-GB" baseline="0" dirty="0" smtClean="0"/>
              <a:t> </a:t>
            </a:r>
            <a:r>
              <a:rPr lang="en-GB" i="1" baseline="0" dirty="0" smtClean="0"/>
              <a:t>Fusarium </a:t>
            </a:r>
            <a:r>
              <a:rPr lang="en-GB" i="0" baseline="0" dirty="0" smtClean="0"/>
              <a:t>disease in Arabidopsis floral and silique tissue, adapted from Urban </a:t>
            </a:r>
            <a:r>
              <a:rPr lang="en-GB" i="1" baseline="0" dirty="0" smtClean="0"/>
              <a:t>et al</a:t>
            </a:r>
            <a:r>
              <a:rPr lang="en-GB" i="0" baseline="0" dirty="0" smtClean="0"/>
              <a:t>., 2002. Plants were given separate scores for floral and silique infection from 0 (no disease) to 7 (constriction of the </a:t>
            </a:r>
            <a:r>
              <a:rPr lang="en-GB" i="0" baseline="0" smtClean="0"/>
              <a:t>main stem).</a:t>
            </a:r>
            <a:r>
              <a:rPr lang="en-GB" sz="1200" smtClean="0">
                <a:solidFill>
                  <a:srgbClr val="000000"/>
                </a:solidFill>
                <a:latin typeface="+mn-lt"/>
              </a:rPr>
              <a:t>The </a:t>
            </a:r>
            <a:r>
              <a:rPr lang="en-GB" sz="1200" dirty="0" smtClean="0">
                <a:solidFill>
                  <a:srgbClr val="000000"/>
                </a:solidFill>
                <a:latin typeface="+mn-lt"/>
              </a:rPr>
              <a:t>intermediate scores of 2 and 4 (F), and 2, 4 and 6 (S) were reserved for when all the tissue on a single plant exhibited the disease phenotype described for the preceding score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930DF4-A33C-4C53-92BB-ADA451148D9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8282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622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980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1499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6633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851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42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062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730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416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188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453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BF9F5-4F96-49B1-8077-0640D6EECBF0}" type="datetimeFigureOut">
              <a:rPr lang="en-GB" smtClean="0"/>
              <a:t>16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93591-D49A-4CFB-B1ED-9F0B8C9A33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204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5667047"/>
              </p:ext>
            </p:extLst>
          </p:nvPr>
        </p:nvGraphicFramePr>
        <p:xfrm>
          <a:off x="539552" y="620688"/>
          <a:ext cx="4176463" cy="2476500"/>
        </p:xfrm>
        <a:graphic>
          <a:graphicData uri="http://schemas.openxmlformats.org/drawingml/2006/table">
            <a:tbl>
              <a:tblPr/>
              <a:tblGrid>
                <a:gridCol w="678890"/>
                <a:gridCol w="549987"/>
                <a:gridCol w="2947586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rg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scription of disease phenotyp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ower (F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disea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erial mycelium visible on flow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rying of flowe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em constriction within flower hea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in stem constric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lique (S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disea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erial mycelium on silique surfa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rying of silique surfa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dicel constriction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or loss of siliques by disease travel within pedic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in stem constric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6146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56</Words>
  <Application>Microsoft Office PowerPoint</Application>
  <PresentationFormat>On-screen Show (4:3)</PresentationFormat>
  <Paragraphs>2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2</cp:revision>
  <dcterms:created xsi:type="dcterms:W3CDTF">2014-09-16T16:47:32Z</dcterms:created>
  <dcterms:modified xsi:type="dcterms:W3CDTF">2014-09-16T16:59:46Z</dcterms:modified>
</cp:coreProperties>
</file>